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172" autoAdjust="0"/>
    <p:restoredTop sz="94660"/>
  </p:normalViewPr>
  <p:slideViewPr>
    <p:cSldViewPr snapToGrid="0">
      <p:cViewPr>
        <p:scale>
          <a:sx n="66" d="100"/>
          <a:sy n="66" d="100"/>
        </p:scale>
        <p:origin x="304" y="1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837F2-2D71-4889-ABBE-8734914D4AD4}" type="datetimeFigureOut">
              <a:rPr lang="zh-TW" altLang="en-US" smtClean="0"/>
              <a:t>2021/1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DE6E5-2D86-4054-809A-C967143B573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271138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837F2-2D71-4889-ABBE-8734914D4AD4}" type="datetimeFigureOut">
              <a:rPr lang="zh-TW" altLang="en-US" smtClean="0"/>
              <a:t>2021/1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DE6E5-2D86-4054-809A-C967143B573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732021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837F2-2D71-4889-ABBE-8734914D4AD4}" type="datetimeFigureOut">
              <a:rPr lang="zh-TW" altLang="en-US" smtClean="0"/>
              <a:t>2021/1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DE6E5-2D86-4054-809A-C967143B573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137784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837F2-2D71-4889-ABBE-8734914D4AD4}" type="datetimeFigureOut">
              <a:rPr lang="zh-TW" altLang="en-US" smtClean="0"/>
              <a:t>2021/1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DE6E5-2D86-4054-809A-C967143B573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639924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837F2-2D71-4889-ABBE-8734914D4AD4}" type="datetimeFigureOut">
              <a:rPr lang="zh-TW" altLang="en-US" smtClean="0"/>
              <a:t>2021/1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DE6E5-2D86-4054-809A-C967143B573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84515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837F2-2D71-4889-ABBE-8734914D4AD4}" type="datetimeFigureOut">
              <a:rPr lang="zh-TW" altLang="en-US" smtClean="0"/>
              <a:t>2021/1/12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DE6E5-2D86-4054-809A-C967143B573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383488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837F2-2D71-4889-ABBE-8734914D4AD4}" type="datetimeFigureOut">
              <a:rPr lang="zh-TW" altLang="en-US" smtClean="0"/>
              <a:t>2021/1/12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DE6E5-2D86-4054-809A-C967143B573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254762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837F2-2D71-4889-ABBE-8734914D4AD4}" type="datetimeFigureOut">
              <a:rPr lang="zh-TW" altLang="en-US" smtClean="0"/>
              <a:t>2021/1/12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DE6E5-2D86-4054-809A-C967143B573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806117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837F2-2D71-4889-ABBE-8734914D4AD4}" type="datetimeFigureOut">
              <a:rPr lang="zh-TW" altLang="en-US" smtClean="0"/>
              <a:t>2021/1/12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DE6E5-2D86-4054-809A-C967143B573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529025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837F2-2D71-4889-ABBE-8734914D4AD4}" type="datetimeFigureOut">
              <a:rPr lang="zh-TW" altLang="en-US" smtClean="0"/>
              <a:t>2021/1/12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DE6E5-2D86-4054-809A-C967143B573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837936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837F2-2D71-4889-ABBE-8734914D4AD4}" type="datetimeFigureOut">
              <a:rPr lang="zh-TW" altLang="en-US" smtClean="0"/>
              <a:t>2021/1/12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DE6E5-2D86-4054-809A-C967143B573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891392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4837F2-2D71-4889-ABBE-8734914D4AD4}" type="datetimeFigureOut">
              <a:rPr lang="zh-TW" altLang="en-US" smtClean="0"/>
              <a:t>2021/1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1DE6E5-2D86-4054-809A-C967143B573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607413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格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91131112"/>
              </p:ext>
            </p:extLst>
          </p:nvPr>
        </p:nvGraphicFramePr>
        <p:xfrm>
          <a:off x="2045423" y="1634199"/>
          <a:ext cx="8216899" cy="3646170"/>
        </p:xfrm>
        <a:graphic>
          <a:graphicData uri="http://schemas.openxmlformats.org/drawingml/2006/table">
            <a:tbl>
              <a:tblPr/>
              <a:tblGrid>
                <a:gridCol w="1399634">
                  <a:extLst>
                    <a:ext uri="{9D8B030D-6E8A-4147-A177-3AD203B41FA5}">
                      <a16:colId xmlns:a16="http://schemas.microsoft.com/office/drawing/2014/main" val="4075451721"/>
                    </a:ext>
                  </a:extLst>
                </a:gridCol>
                <a:gridCol w="980696">
                  <a:extLst>
                    <a:ext uri="{9D8B030D-6E8A-4147-A177-3AD203B41FA5}">
                      <a16:colId xmlns:a16="http://schemas.microsoft.com/office/drawing/2014/main" val="3417692169"/>
                    </a:ext>
                  </a:extLst>
                </a:gridCol>
                <a:gridCol w="2856396">
                  <a:extLst>
                    <a:ext uri="{9D8B030D-6E8A-4147-A177-3AD203B41FA5}">
                      <a16:colId xmlns:a16="http://schemas.microsoft.com/office/drawing/2014/main" val="1794361588"/>
                    </a:ext>
                  </a:extLst>
                </a:gridCol>
                <a:gridCol w="2980173">
                  <a:extLst>
                    <a:ext uri="{9D8B030D-6E8A-4147-A177-3AD203B41FA5}">
                      <a16:colId xmlns:a16="http://schemas.microsoft.com/office/drawing/2014/main" val="2136074973"/>
                    </a:ext>
                  </a:extLst>
                </a:gridCol>
              </a:tblGrid>
              <a:tr h="213360"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Supplementary Table </a:t>
                      </a:r>
                      <a:r>
                        <a:rPr lang="en-US" sz="120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2.  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Primer sequences used for qPCR in this study</a:t>
                      </a:r>
                    </a:p>
                  </a:txBody>
                  <a:tcPr marL="3810" marR="3810" marT="38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0391181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Primer Name</a:t>
                      </a:r>
                    </a:p>
                  </a:txBody>
                  <a:tcPr marL="3810" marR="3810" marT="38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Species 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Forword primer sequence (5'-3') 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Reverse primer sequence (5'-3')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0634685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IL-1</a:t>
                      </a:r>
                      <a:r>
                        <a:rPr lang="el-G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β</a:t>
                      </a:r>
                    </a:p>
                  </a:txBody>
                  <a:tcPr marL="3810" marR="3810" marT="38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Human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ACGAATCTCCGACCACCACT  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CCATGGCCACAACAACTGAC  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109849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IL-6</a:t>
                      </a:r>
                    </a:p>
                  </a:txBody>
                  <a:tcPr marL="3810" marR="3810" marT="38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Human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AGCGCCTTCGGTCCAGTTGC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GTGGCTGTCTGTGTGGGGCG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176004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IL-8</a:t>
                      </a:r>
                    </a:p>
                  </a:txBody>
                  <a:tcPr marL="3810" marR="3810" marT="38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Human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CTGGCCGTGGCTCTCTTG  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CCTTGGCAAAACTGCACCTT  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893377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IL-23p19</a:t>
                      </a:r>
                    </a:p>
                  </a:txBody>
                  <a:tcPr marL="3810" marR="3810" marT="38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Human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TCCAAGCCTCAGTCCCAG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TGGGGTGGTAGATTTATCTTGG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849437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IL-24</a:t>
                      </a:r>
                    </a:p>
                  </a:txBody>
                  <a:tcPr marL="3810" marR="3810" marT="38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Human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CAGGAGGAACACGAGACTGA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GCACAACCATCTGCATTTGAGA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378141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TNF</a:t>
                      </a:r>
                    </a:p>
                  </a:txBody>
                  <a:tcPr marL="3810" marR="3810" marT="38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Human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ATGAGCACTGAAAGCATGATCC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GAGGGCTGATTAGAGAGAGGTC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8897269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GAPDH</a:t>
                      </a:r>
                    </a:p>
                  </a:txBody>
                  <a:tcPr marL="3810" marR="3810" marT="38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Human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TGCACCACCAACTGCTTAGC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GGCATGGACTGTGGTCATGAG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972449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GDAP1L1</a:t>
                      </a:r>
                    </a:p>
                  </a:txBody>
                  <a:tcPr marL="3810" marR="3810" marT="38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Human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CTCTGAATGGGGCTGGATAA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ACCCAACACATGGACCAAAT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895524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CCL1</a:t>
                      </a:r>
                    </a:p>
                  </a:txBody>
                  <a:tcPr marL="3810" marR="3810" marT="38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Human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CATTTGCGGAGCAAGAGATT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TGCCTCAGCATTTTTCTGTG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116429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CCL2</a:t>
                      </a:r>
                    </a:p>
                  </a:txBody>
                  <a:tcPr marL="3810" marR="3810" marT="38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Human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CCCCAGTCACCTGCTGTTAT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TGGAATCCTGAACCCACTTC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9449919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CCL4L2 </a:t>
                      </a:r>
                    </a:p>
                  </a:txBody>
                  <a:tcPr marL="3810" marR="3810" marT="38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Human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GAAAACCTCTTTGCCACCAA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ACCACAAAGTTGCGAGGAAG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114391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CCL20</a:t>
                      </a:r>
                    </a:p>
                  </a:txBody>
                  <a:tcPr marL="3810" marR="3810" marT="381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Human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GCGCAAATCCAAAACAGACT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CAAGTCCAGTGAGGCACAAA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485615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CCL22</a:t>
                      </a:r>
                    </a:p>
                  </a:txBody>
                  <a:tcPr marL="3810" marR="3810" marT="38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Human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ACTGCACTCCTGGTTGTCCT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GCTCTTCATTGGCTCAGCTT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296674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CXCL3</a:t>
                      </a:r>
                    </a:p>
                  </a:txBody>
                  <a:tcPr marL="3810" marR="3810" marT="38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Human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TGGTCACTGAACTGCGCT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ATGCGGGGTTGAGACAAG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947733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CXCL6</a:t>
                      </a:r>
                    </a:p>
                  </a:txBody>
                  <a:tcPr marL="3810" marR="3810" marT="38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Human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GCTTGAGTTTCCTGCCAGTC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GGGAGGCTCATAGTGGTCAA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2218022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CXCR5</a:t>
                      </a:r>
                    </a:p>
                  </a:txBody>
                  <a:tcPr marL="3810" marR="3810" marT="38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Human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GCTAACGCTGGAAATGGA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GCAGGGCAGAGATGATTT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19252703"/>
                  </a:ext>
                </a:extLst>
              </a:tr>
              <a:tr h="19431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CCR7</a:t>
                      </a:r>
                    </a:p>
                  </a:txBody>
                  <a:tcPr marL="3810" marR="3810" marT="38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Human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GATGCGATGCTCTCTCATCA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TGTAGGGCAGCTGGAAGACT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02441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005851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65</TotalTime>
  <Words>100</Words>
  <Application>Microsoft Office PowerPoint</Application>
  <PresentationFormat>寬螢幕</PresentationFormat>
  <Paragraphs>73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6" baseType="lpstr">
      <vt:lpstr>新細明體</vt:lpstr>
      <vt:lpstr>Arial</vt:lpstr>
      <vt:lpstr>Calibri</vt:lpstr>
      <vt:lpstr>Calibri Light</vt:lpstr>
      <vt:lpstr>Office 佈景主題</vt:lpstr>
      <vt:lpstr>PowerPoint 簡報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士億 莊</dc:creator>
  <cp:lastModifiedBy>莊士億</cp:lastModifiedBy>
  <cp:revision>31</cp:revision>
  <dcterms:created xsi:type="dcterms:W3CDTF">2020-02-11T03:17:50Z</dcterms:created>
  <dcterms:modified xsi:type="dcterms:W3CDTF">2021-01-12T02:31:15Z</dcterms:modified>
</cp:coreProperties>
</file>